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1" r:id="rId2"/>
    <p:sldId id="278" r:id="rId3"/>
    <p:sldId id="28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0A1FCC6-4195-A969-0267-79971AD71C22}" name="rakshita bhat" initials="rb" userId="0e561e82d3d9113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9" autoAdjust="0"/>
    <p:restoredTop sz="94648"/>
  </p:normalViewPr>
  <p:slideViewPr>
    <p:cSldViewPr snapToGrid="0">
      <p:cViewPr varScale="1">
        <p:scale>
          <a:sx n="59" d="100"/>
          <a:sy n="59" d="100"/>
        </p:scale>
        <p:origin x="9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85CE55-9B2D-4975-93D7-60D267EAE680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DEAA5D-E8C6-4B71-AB7B-C7DB29A93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861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DEAA5D-E8C6-4B71-AB7B-C7DB29A93FF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809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957E58-E011-9EBB-1717-C19D17A2A7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A45EC2-4E31-2A39-28F5-FCA4248EBE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A6FA36-1F46-C0A4-7B0E-12B8DC7B1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9B3C6-A811-5BCC-72B5-D83C850E0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88FD69-FCA8-F40D-A70B-7B1705566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048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07C92-0BE9-DC7D-E431-B124805D94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4BA94D-C31C-96D8-3B65-0A6C9521CF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3AA831-3890-2E84-FB68-41329B579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611423-227C-B19C-9D51-E135281BF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4483D-E705-DA68-3752-7B24088D0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289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067B06-63CE-FC7B-F5A3-2E52F36566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FAD401-DA14-9D3F-C843-C2CE290DA1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B2538-66F7-51D4-CF85-436C59353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E45AB4-58F1-ADF4-256E-1B41542B0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808787-C7AA-E991-BD1A-7CF7DB32E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81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659E8-468E-2849-89E7-93FE5E8DE8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C2D61D-AB2B-AFCA-EE2E-949FE7194D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EBB5F3-1FE6-4E5A-0901-8BC3F609D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A3DFDC-B69C-1A6A-2B88-3BE83B234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34B83D-8DD8-E8F8-F050-47187E34E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095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91474-D912-5FEC-BB5C-2F074D36E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5FA7A-68FC-36A8-841B-7612E4E576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EA778C-E22F-05CE-76D6-9B4FCBC99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7E233-8BE1-8159-BB93-EA679D621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2822E6-DB71-4BAD-ED45-E744FAE11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11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7C37EA-DDAD-A6F7-52D6-9FA238940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BA6BCB-80A4-A968-6B4D-CCF4B275DC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331452-2ED5-B084-2E9C-898D765B09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A265F3-A631-3603-1AEA-57E3D341A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4CBC4-8A89-408B-9ED0-2445D54E1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853028-C011-A7C0-B37F-626926D2B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227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5CD5A-37D3-B939-3FE7-4E033D867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9C3615-9A7B-07CD-C9D8-7C094D0BF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2A9396-10ED-9759-88C8-A3B3406BE8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835C6C-622A-5065-7A36-B48743A0F3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AA539D-0176-C1DA-D365-A2A5E9C384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670856-0A59-FEA2-C452-DBE585CF2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D88141-085D-1E32-A907-649058906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F5B3C7-8998-8B78-C59D-121805666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722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AF26B-991B-B5D3-715A-72B7CDEBC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9BC125-1F2E-F8E6-3832-2C05476B0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FA6A83-1A59-9902-1B42-5B11CB99E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E6F9CA-644F-60D4-5A93-A167CD69D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116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24FAA7-5415-A912-14AD-402B28BD7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A3DC4B-C878-1E7A-780E-25E5C992C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7E6596-CDC0-ED7A-FE49-37B613C57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421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E2D2A-80A5-FDE9-CD9F-DAB31941F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7745B7-82EE-3FB3-1710-545341B3A1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59EAB6-2C6D-7638-12F3-D2E777ABD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3DC4F4-69EC-752F-2C74-BB6001FE4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01E3A6-479C-71AE-1C3A-19AFCE95E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3BC129-356C-693E-44D5-33A012C49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299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1A70B-F8E9-B640-27EA-6CCA1A36E9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0716A5-4675-196F-393B-A9E41EBA9B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EA05F5-209B-A0FC-C4FA-88F0FE5F26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B86923-A853-1823-6D5E-D1D293FA4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932DC7-D5D4-ABA5-2035-10D95187E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A3BB8-ABB4-052A-E3DC-4C63F6606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013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F21985-6E7C-DF2B-B1DD-4C6E2ACCA4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64AD40-0897-56AF-9C7D-C7C867BB5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648E6D-F246-A433-57FA-33D9E0E318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AD6E1C-73D4-4882-8ABE-4045AD9942DB}" type="datetimeFigureOut">
              <a:rPr lang="en-US" smtClean="0"/>
              <a:t>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9DD73D-D087-CAE8-9E2A-134DFC08DB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42F5A-9329-BF3E-F8FE-AA8D15037C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5217E7-F986-44BD-B04C-E04890243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73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6AB11FD-F3DB-3A8F-8411-C2825BA93BC6}"/>
              </a:ext>
            </a:extLst>
          </p:cNvPr>
          <p:cNvSpPr txBox="1"/>
          <p:nvPr/>
        </p:nvSpPr>
        <p:spPr>
          <a:xfrm>
            <a:off x="2056695" y="1252534"/>
            <a:ext cx="19601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kern="10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b="1" kern="10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l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E49259A-70DB-95E8-E05F-78B6ACA68C86}"/>
              </a:ext>
            </a:extLst>
          </p:cNvPr>
          <p:cNvGrpSpPr/>
          <p:nvPr/>
        </p:nvGrpSpPr>
        <p:grpSpPr>
          <a:xfrm>
            <a:off x="1874848" y="1487903"/>
            <a:ext cx="7818648" cy="3297530"/>
            <a:chOff x="1874848" y="1487903"/>
            <a:chExt cx="7818648" cy="329753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7A63944-92AF-6258-ED42-33B0309AAEB6}"/>
                </a:ext>
              </a:extLst>
            </p:cNvPr>
            <p:cNvGrpSpPr/>
            <p:nvPr/>
          </p:nvGrpSpPr>
          <p:grpSpPr>
            <a:xfrm>
              <a:off x="1874848" y="2870715"/>
              <a:ext cx="7818648" cy="1633212"/>
              <a:chOff x="1874848" y="2870715"/>
              <a:chExt cx="7818648" cy="1633212"/>
            </a:xfrm>
          </p:grpSpPr>
          <p:pic>
            <p:nvPicPr>
              <p:cNvPr id="9" name="Picture 8" descr="A graph showing the number of different types of data&#10;&#10;Description automatically generated with medium confidence">
                <a:extLst>
                  <a:ext uri="{FF2B5EF4-FFF2-40B4-BE49-F238E27FC236}">
                    <a16:creationId xmlns:a16="http://schemas.microsoft.com/office/drawing/2014/main" id="{8CAEE88D-4340-951A-E0A0-54C8F42D29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7" t="22351" r="3319" b="10601"/>
              <a:stretch/>
            </p:blipFill>
            <p:spPr>
              <a:xfrm>
                <a:off x="1874848" y="2870715"/>
                <a:ext cx="3462299" cy="1633212"/>
              </a:xfrm>
              <a:prstGeom prst="rect">
                <a:avLst/>
              </a:prstGeom>
            </p:spPr>
          </p:pic>
          <p:pic>
            <p:nvPicPr>
              <p:cNvPr id="11" name="Picture 10" descr="A graph of a number of people&#10;&#10;Description automatically generated">
                <a:extLst>
                  <a:ext uri="{FF2B5EF4-FFF2-40B4-BE49-F238E27FC236}">
                    <a16:creationId xmlns:a16="http://schemas.microsoft.com/office/drawing/2014/main" id="{25F7869E-2D40-CF62-A63B-9D7043A0F9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967" t="1606" r="9578" b="36274"/>
              <a:stretch/>
            </p:blipFill>
            <p:spPr>
              <a:xfrm>
                <a:off x="8472035" y="2899627"/>
                <a:ext cx="1221461" cy="1259014"/>
              </a:xfrm>
              <a:prstGeom prst="rect">
                <a:avLst/>
              </a:prstGeom>
            </p:spPr>
          </p:pic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12BD5B1-DAFD-F9EE-652E-C569D5F3D367}"/>
                </a:ext>
              </a:extLst>
            </p:cNvPr>
            <p:cNvSpPr txBox="1"/>
            <p:nvPr/>
          </p:nvSpPr>
          <p:spPr>
            <a:xfrm>
              <a:off x="2121769" y="1999098"/>
              <a:ext cx="48109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b="1" kern="1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A.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D5F2F74-C144-2A91-B890-8AF4533E8EAF}"/>
                </a:ext>
              </a:extLst>
            </p:cNvPr>
            <p:cNvSpPr txBox="1"/>
            <p:nvPr/>
          </p:nvSpPr>
          <p:spPr>
            <a:xfrm>
              <a:off x="6351790" y="2026401"/>
              <a:ext cx="48109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b="1" kern="1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.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90FD508-FC24-A673-AD84-52D29052CC30}"/>
                </a:ext>
              </a:extLst>
            </p:cNvPr>
            <p:cNvSpPr txBox="1"/>
            <p:nvPr/>
          </p:nvSpPr>
          <p:spPr>
            <a:xfrm>
              <a:off x="2056696" y="4354546"/>
              <a:ext cx="1801368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 MLD (mm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66CABFB-980F-CDC3-ED67-A02759B1EA9C}"/>
                </a:ext>
              </a:extLst>
            </p:cNvPr>
            <p:cNvSpPr txBox="1"/>
            <p:nvPr/>
          </p:nvSpPr>
          <p:spPr>
            <a:xfrm>
              <a:off x="6252456" y="4354546"/>
              <a:ext cx="2162449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  <a:r>
                <a: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 lumen area (mm</a:t>
              </a:r>
              <a:r>
                <a:rPr kumimoji="0" lang="en-US" sz="9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E9D2ABF-EC67-8D2B-2B05-5688F5DA2D3B}"/>
                </a:ext>
              </a:extLst>
            </p:cNvPr>
            <p:cNvSpPr txBox="1"/>
            <p:nvPr/>
          </p:nvSpPr>
          <p:spPr>
            <a:xfrm>
              <a:off x="4272113" y="1487903"/>
              <a:ext cx="180136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         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 </a:t>
              </a: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licone models</a:t>
              </a:r>
              <a:endPara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7805FB3-8A5F-30A9-04C3-8AE2F297DE00}"/>
              </a:ext>
            </a:extLst>
          </p:cNvPr>
          <p:cNvSpPr txBox="1"/>
          <p:nvPr/>
        </p:nvSpPr>
        <p:spPr>
          <a:xfrm rot="16200000">
            <a:off x="855147" y="3238418"/>
            <a:ext cx="180136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LD difference (mm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D30D48-E42A-596B-0E24-38CCD36174C6}"/>
              </a:ext>
            </a:extLst>
          </p:cNvPr>
          <p:cNvSpPr txBox="1"/>
          <p:nvPr/>
        </p:nvSpPr>
        <p:spPr>
          <a:xfrm rot="16200000">
            <a:off x="4693842" y="3405794"/>
            <a:ext cx="232839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umen area difference (mm</a:t>
            </a:r>
            <a:r>
              <a:rPr kumimoji="0" lang="en-US" sz="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9" name="Picture 18" descr="A graph showing a number of dots&#10;&#10;Description automatically generated with medium confidence">
            <a:extLst>
              <a:ext uri="{FF2B5EF4-FFF2-40B4-BE49-F238E27FC236}">
                <a16:creationId xmlns:a16="http://schemas.microsoft.com/office/drawing/2014/main" id="{7A51A949-EFAF-CECA-9E6F-37A325F61F6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9905" y="2846342"/>
            <a:ext cx="2447552" cy="168195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BAB0CCF-AE78-8070-D11E-CCB7AE22CCAA}"/>
              </a:ext>
            </a:extLst>
          </p:cNvPr>
          <p:cNvSpPr txBox="1"/>
          <p:nvPr/>
        </p:nvSpPr>
        <p:spPr>
          <a:xfrm>
            <a:off x="2139450" y="2572291"/>
            <a:ext cx="2407787" cy="3847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D IVUS (</a:t>
            </a:r>
            <a:r>
              <a:rPr kumimoji="0" lang="en-US" sz="9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vvigo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) vs. OCT (</a:t>
            </a:r>
            <a:r>
              <a:rPr kumimoji="0" lang="en-US" sz="9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ltreon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.0)</a:t>
            </a:r>
            <a:b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98F172-EB74-0B93-D938-E0B8D9962197}"/>
              </a:ext>
            </a:extLst>
          </p:cNvPr>
          <p:cNvSpPr txBox="1"/>
          <p:nvPr/>
        </p:nvSpPr>
        <p:spPr>
          <a:xfrm>
            <a:off x="6186094" y="2535887"/>
            <a:ext cx="2407787" cy="3847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D IVUS (</a:t>
            </a:r>
            <a:r>
              <a:rPr kumimoji="0" lang="en-US" sz="9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vvigo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) vs. OCT (</a:t>
            </a:r>
            <a:r>
              <a:rPr kumimoji="0" lang="en-US" sz="9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ltreon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.0)</a:t>
            </a:r>
            <a:b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72E773-85B0-3CC8-9B84-F22E9632F526}"/>
              </a:ext>
            </a:extLst>
          </p:cNvPr>
          <p:cNvSpPr txBox="1"/>
          <p:nvPr/>
        </p:nvSpPr>
        <p:spPr>
          <a:xfrm>
            <a:off x="1462386" y="4820772"/>
            <a:ext cx="8429759" cy="1144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1. Bland Altman analysis of HD IVU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oston Scientific: HD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pticros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-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vvigo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)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vs. OC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bbott: Dragonfly Optis - Optis -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ltreon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2.0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in silicone models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A) HD IVUS compared with OCT of MLD; (B) HD IVUS compared with OCT of lumen area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7513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EA5264-9875-F770-74D0-70A7B4739AE9}"/>
              </a:ext>
            </a:extLst>
          </p:cNvPr>
          <p:cNvSpPr txBox="1"/>
          <p:nvPr/>
        </p:nvSpPr>
        <p:spPr>
          <a:xfrm>
            <a:off x="1766869" y="67336"/>
            <a:ext cx="19674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l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2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97B39924-F516-261A-32E2-D35E6EEF6168}"/>
              </a:ext>
            </a:extLst>
          </p:cNvPr>
          <p:cNvGrpSpPr/>
          <p:nvPr/>
        </p:nvGrpSpPr>
        <p:grpSpPr>
          <a:xfrm>
            <a:off x="1823962" y="46787"/>
            <a:ext cx="8321922" cy="5527348"/>
            <a:chOff x="1297291" y="649238"/>
            <a:chExt cx="8321922" cy="5527348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BDAF813-08EF-D7D6-C863-E0DAC5034F6A}"/>
                </a:ext>
              </a:extLst>
            </p:cNvPr>
            <p:cNvSpPr txBox="1"/>
            <p:nvPr/>
          </p:nvSpPr>
          <p:spPr>
            <a:xfrm>
              <a:off x="4120456" y="649238"/>
              <a:ext cx="180136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         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 </a:t>
              </a: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licone models</a:t>
              </a:r>
              <a:endPara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95A21EBB-C573-2F58-F7B1-9EB66E127D3E}"/>
                </a:ext>
              </a:extLst>
            </p:cNvPr>
            <p:cNvGrpSpPr/>
            <p:nvPr/>
          </p:nvGrpSpPr>
          <p:grpSpPr>
            <a:xfrm>
              <a:off x="1297291" y="1093546"/>
              <a:ext cx="8321922" cy="5083040"/>
              <a:chOff x="1297291" y="1093546"/>
              <a:chExt cx="8321922" cy="5083040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D87DE926-8728-5E76-2C67-7E09ED4652CD}"/>
                  </a:ext>
                </a:extLst>
              </p:cNvPr>
              <p:cNvGrpSpPr/>
              <p:nvPr/>
            </p:nvGrpSpPr>
            <p:grpSpPr>
              <a:xfrm>
                <a:off x="1297291" y="1647300"/>
                <a:ext cx="8321922" cy="4313843"/>
                <a:chOff x="1297291" y="1647300"/>
                <a:chExt cx="8321922" cy="4313843"/>
              </a:xfrm>
            </p:grpSpPr>
            <p:pic>
              <p:nvPicPr>
                <p:cNvPr id="5" name="Picture 4" descr="A diagram of a number of different types of blotc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38BA5E36-0D0C-7998-7454-E007C01E1E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341" t="1471" r="3750" b="14962"/>
                <a:stretch/>
              </p:blipFill>
              <p:spPr>
                <a:xfrm>
                  <a:off x="1297291" y="1671316"/>
                  <a:ext cx="3439926" cy="1571050"/>
                </a:xfrm>
                <a:prstGeom prst="rect">
                  <a:avLst/>
                </a:prstGeom>
              </p:spPr>
            </p:pic>
            <p:pic>
              <p:nvPicPr>
                <p:cNvPr id="8" name="Picture 7" descr="A graph of different sizes and numbe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2C89835F-D03F-278E-B612-ED367BD889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33" t="4778" r="1476" b="8545"/>
                <a:stretch/>
              </p:blipFill>
              <p:spPr>
                <a:xfrm>
                  <a:off x="1366342" y="4276346"/>
                  <a:ext cx="3474464" cy="1602738"/>
                </a:xfrm>
                <a:prstGeom prst="rect">
                  <a:avLst/>
                </a:prstGeom>
              </p:spPr>
            </p:pic>
            <p:pic>
              <p:nvPicPr>
                <p:cNvPr id="11" name="Picture 10" descr="A diagram of a normal area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48D10935-7D33-994B-402A-38D20D1894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59" t="4842" r="4389" b="12859"/>
                <a:stretch/>
              </p:blipFill>
              <p:spPr>
                <a:xfrm>
                  <a:off x="6047509" y="1647300"/>
                  <a:ext cx="3439926" cy="1571050"/>
                </a:xfrm>
                <a:prstGeom prst="rect">
                  <a:avLst/>
                </a:prstGeom>
              </p:spPr>
            </p:pic>
            <p:pic>
              <p:nvPicPr>
                <p:cNvPr id="18" name="Picture 17" descr="A diagram of a normal area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8D8903D0-4E9C-F3F4-E16B-77577A2A78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81" t="1551" r="2912" b="12396"/>
                <a:stretch/>
              </p:blipFill>
              <p:spPr>
                <a:xfrm>
                  <a:off x="6149037" y="4322791"/>
                  <a:ext cx="3470176" cy="1638352"/>
                </a:xfrm>
                <a:prstGeom prst="rect">
                  <a:avLst/>
                </a:prstGeom>
              </p:spPr>
            </p:pic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6732BF3-BB63-39D8-B794-D58A584B977B}"/>
                  </a:ext>
                </a:extLst>
              </p:cNvPr>
              <p:cNvSpPr txBox="1"/>
              <p:nvPr/>
            </p:nvSpPr>
            <p:spPr>
              <a:xfrm>
                <a:off x="1587177" y="2998113"/>
                <a:ext cx="1801368" cy="43088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verage MLD (mm)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67C2451-9A3F-DA12-1F1E-23FD91BAEB13}"/>
                  </a:ext>
                </a:extLst>
              </p:cNvPr>
              <p:cNvSpPr txBox="1"/>
              <p:nvPr/>
            </p:nvSpPr>
            <p:spPr>
              <a:xfrm>
                <a:off x="1587177" y="5666661"/>
                <a:ext cx="1801368" cy="43088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9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verage MLD (mm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034FB6E-CC68-E877-7FE8-7B282C827F01}"/>
                  </a:ext>
                </a:extLst>
              </p:cNvPr>
              <p:cNvSpPr txBox="1"/>
              <p:nvPr/>
            </p:nvSpPr>
            <p:spPr>
              <a:xfrm>
                <a:off x="6254874" y="5745699"/>
                <a:ext cx="2328390" cy="43088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verage lumen area (mm</a:t>
                </a:r>
                <a:r>
                  <a:rPr kumimoji="0" lang="en-US" sz="900" b="1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ABC3D89-FDC2-3473-79E8-0B772D2177D9}"/>
                  </a:ext>
                </a:extLst>
              </p:cNvPr>
              <p:cNvSpPr txBox="1"/>
              <p:nvPr/>
            </p:nvSpPr>
            <p:spPr>
              <a:xfrm>
                <a:off x="6109957" y="2993059"/>
                <a:ext cx="2328390" cy="43088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verage lumen area (mm</a:t>
                </a:r>
                <a:r>
                  <a:rPr kumimoji="0" lang="en-US" sz="900" b="1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2A3361A-C9A2-44BA-364B-3287D6BF4F5D}"/>
                  </a:ext>
                </a:extLst>
              </p:cNvPr>
              <p:cNvSpPr txBox="1"/>
              <p:nvPr/>
            </p:nvSpPr>
            <p:spPr>
              <a:xfrm>
                <a:off x="1404803" y="1093546"/>
                <a:ext cx="481099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b="1" kern="100" dirty="0"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A.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B440E92-3E11-3933-4FD0-267E0D2C9034}"/>
                  </a:ext>
                </a:extLst>
              </p:cNvPr>
              <p:cNvSpPr txBox="1"/>
              <p:nvPr/>
            </p:nvSpPr>
            <p:spPr>
              <a:xfrm>
                <a:off x="6149037" y="1110903"/>
                <a:ext cx="481099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b="1" kern="100" dirty="0"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B.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E40B11A-164C-A888-D18E-3A3413C04CBE}"/>
                  </a:ext>
                </a:extLst>
              </p:cNvPr>
              <p:cNvSpPr txBox="1"/>
              <p:nvPr/>
            </p:nvSpPr>
            <p:spPr>
              <a:xfrm>
                <a:off x="1404802" y="3730298"/>
                <a:ext cx="481099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b="1" kern="100" dirty="0"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C.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A254B2B-38CD-7233-C0C1-F42FB2F0C412}"/>
                  </a:ext>
                </a:extLst>
              </p:cNvPr>
              <p:cNvSpPr txBox="1"/>
              <p:nvPr/>
            </p:nvSpPr>
            <p:spPr>
              <a:xfrm>
                <a:off x="6189185" y="3730298"/>
                <a:ext cx="481099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b="1" kern="100" dirty="0"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D.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D630F1FA-86AF-0188-A149-B4523F4F6537}"/>
              </a:ext>
            </a:extLst>
          </p:cNvPr>
          <p:cNvSpPr txBox="1"/>
          <p:nvPr/>
        </p:nvSpPr>
        <p:spPr>
          <a:xfrm rot="16200000">
            <a:off x="667706" y="1370062"/>
            <a:ext cx="180136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LD difference (mm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FB9A6C4-4CF0-E8D5-7EAC-B80D94168A06}"/>
              </a:ext>
            </a:extLst>
          </p:cNvPr>
          <p:cNvSpPr txBox="1"/>
          <p:nvPr/>
        </p:nvSpPr>
        <p:spPr>
          <a:xfrm rot="16200000">
            <a:off x="5242454" y="1501464"/>
            <a:ext cx="232839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umen area difference (mm</a:t>
            </a:r>
            <a:r>
              <a:rPr kumimoji="0" lang="en-US" sz="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8DF5AEB-1155-6693-C231-D35199FE8050}"/>
              </a:ext>
            </a:extLst>
          </p:cNvPr>
          <p:cNvSpPr txBox="1"/>
          <p:nvPr/>
        </p:nvSpPr>
        <p:spPr>
          <a:xfrm rot="16200000">
            <a:off x="650741" y="3908272"/>
            <a:ext cx="180136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LD difference (mm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D2F6A8-DBC3-AE64-1CF0-5F6EC592EBF8}"/>
              </a:ext>
            </a:extLst>
          </p:cNvPr>
          <p:cNvSpPr txBox="1"/>
          <p:nvPr/>
        </p:nvSpPr>
        <p:spPr>
          <a:xfrm rot="16200000">
            <a:off x="5253072" y="4299237"/>
            <a:ext cx="232839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umen area difference (mm</a:t>
            </a:r>
            <a:r>
              <a:rPr kumimoji="0" lang="en-US" sz="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4DAF9AA-63D8-0666-DE36-CB9BA17E84A1}"/>
              </a:ext>
            </a:extLst>
          </p:cNvPr>
          <p:cNvSpPr txBox="1"/>
          <p:nvPr/>
        </p:nvSpPr>
        <p:spPr>
          <a:xfrm>
            <a:off x="6909421" y="684820"/>
            <a:ext cx="1888251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D IVUS (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vvigo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) reproducibility</a:t>
            </a:r>
            <a:b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B369A31-D661-60E4-8ED7-379D251C4D59}"/>
              </a:ext>
            </a:extLst>
          </p:cNvPr>
          <p:cNvSpPr txBox="1"/>
          <p:nvPr/>
        </p:nvSpPr>
        <p:spPr>
          <a:xfrm>
            <a:off x="2109205" y="3338150"/>
            <a:ext cx="195567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CT (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ltreon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.0) reproducibility</a:t>
            </a:r>
            <a:b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DF78EA-ACB5-1AA3-9FA3-89CEE6B9BED7}"/>
              </a:ext>
            </a:extLst>
          </p:cNvPr>
          <p:cNvSpPr txBox="1"/>
          <p:nvPr/>
        </p:nvSpPr>
        <p:spPr>
          <a:xfrm>
            <a:off x="2270881" y="801458"/>
            <a:ext cx="1888251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D IVUS (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vvigo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) reproducibility</a:t>
            </a:r>
            <a:b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891C81A-150D-1E77-57CE-6601B1588E5F}"/>
              </a:ext>
            </a:extLst>
          </p:cNvPr>
          <p:cNvSpPr txBox="1"/>
          <p:nvPr/>
        </p:nvSpPr>
        <p:spPr>
          <a:xfrm>
            <a:off x="6842000" y="3337390"/>
            <a:ext cx="195567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CT (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ltreon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2.0) reproducibility</a:t>
            </a:r>
            <a:b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68E71E5-6C46-90E3-8172-9A356E770791}"/>
              </a:ext>
            </a:extLst>
          </p:cNvPr>
          <p:cNvSpPr txBox="1"/>
          <p:nvPr/>
        </p:nvSpPr>
        <p:spPr>
          <a:xfrm>
            <a:off x="1007104" y="5607516"/>
            <a:ext cx="9843495" cy="1144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2. Reproducibility of HD IVU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oston Scientific: HD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pticros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-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vvigo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)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, OC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bbott: Dragonfly Optis - Optis -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ltreon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2.0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in silicone models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A) HD IVUS reproducibility of MLD; (B) HD IVUS reproducibility of lumen area; (C) OCT reproducibility of MLD; (D) OCT reproducibility of lumen area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2580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 descr="A black hole in the sky&#10;&#10;Description automatically generated">
            <a:extLst>
              <a:ext uri="{FF2B5EF4-FFF2-40B4-BE49-F238E27FC236}">
                <a16:creationId xmlns:a16="http://schemas.microsoft.com/office/drawing/2014/main" id="{B7D4AD08-18B1-9DD8-EC01-B743805D4E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" r="4452" b="7548"/>
          <a:stretch/>
        </p:blipFill>
        <p:spPr>
          <a:xfrm>
            <a:off x="6301563" y="2153823"/>
            <a:ext cx="1908832" cy="181990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07CDED1-BD10-2F89-DA42-D7EA1D205993}"/>
              </a:ext>
            </a:extLst>
          </p:cNvPr>
          <p:cNvSpPr txBox="1"/>
          <p:nvPr/>
        </p:nvSpPr>
        <p:spPr>
          <a:xfrm>
            <a:off x="3267024" y="1747418"/>
            <a:ext cx="60952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</a:t>
            </a:r>
            <a:r>
              <a:rPr lang="en-US" sz="1200" b="1" kern="100" dirty="0">
                <a:latin typeface="Times New Roman" panose="02020603050405020304" pitchFamily="18" charset="0"/>
                <a:ea typeface="DengXian" panose="02010600030101010101" pitchFamily="2" charset="-122"/>
              </a:rPr>
              <a:t>l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Figure S3</a:t>
            </a:r>
            <a:r>
              <a:rPr lang="en-US" sz="1200" b="1" kern="100" dirty="0">
                <a:latin typeface="Times New Roman" panose="02020603050405020304" pitchFamily="18" charset="0"/>
                <a:ea typeface="DengXian" panose="02010600030101010101" pitchFamily="2" charset="-122"/>
              </a:rPr>
              <a:t>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386C1D6-CEF3-B9C4-2928-8B6CE6D01490}"/>
              </a:ext>
            </a:extLst>
          </p:cNvPr>
          <p:cNvGrpSpPr/>
          <p:nvPr/>
        </p:nvGrpSpPr>
        <p:grpSpPr>
          <a:xfrm>
            <a:off x="3989632" y="2524038"/>
            <a:ext cx="4010725" cy="2607588"/>
            <a:chOff x="3989632" y="2524038"/>
            <a:chExt cx="4010725" cy="2607588"/>
          </a:xfrm>
        </p:grpSpPr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DE984791-CB6B-2506-5C2E-2AC35A70A7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58983" y="4856077"/>
              <a:ext cx="149470" cy="215411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6" name="TextBox 89">
              <a:extLst>
                <a:ext uri="{FF2B5EF4-FFF2-40B4-BE49-F238E27FC236}">
                  <a16:creationId xmlns:a16="http://schemas.microsoft.com/office/drawing/2014/main" id="{2AA0990F-F8C0-BEDD-2A2E-A3F796117A88}"/>
                </a:ext>
              </a:extLst>
            </p:cNvPr>
            <p:cNvSpPr txBox="1"/>
            <p:nvPr/>
          </p:nvSpPr>
          <p:spPr>
            <a:xfrm>
              <a:off x="3989632" y="4647082"/>
              <a:ext cx="60869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Intima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C41E2DCC-8B4E-99DA-43C1-7C8E66DB1C3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63570" y="4749334"/>
              <a:ext cx="363742" cy="4117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776CED6E-18EA-42AB-625F-DCBDAB929FEC}"/>
                </a:ext>
              </a:extLst>
            </p:cNvPr>
            <p:cNvCxnSpPr>
              <a:cxnSpLocks/>
            </p:cNvCxnSpPr>
            <p:nvPr/>
          </p:nvCxnSpPr>
          <p:spPr>
            <a:xfrm>
              <a:off x="5034539" y="4190442"/>
              <a:ext cx="0" cy="314013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D5D51338-7349-F527-1D4F-CD2BF95562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98799" y="4733833"/>
              <a:ext cx="1715" cy="197835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0" name="TextBox 89">
              <a:extLst>
                <a:ext uri="{FF2B5EF4-FFF2-40B4-BE49-F238E27FC236}">
                  <a16:creationId xmlns:a16="http://schemas.microsoft.com/office/drawing/2014/main" id="{2B7D71B9-20F8-2333-A94E-4A7E553D0CE6}"/>
                </a:ext>
              </a:extLst>
            </p:cNvPr>
            <p:cNvSpPr txBox="1"/>
            <p:nvPr/>
          </p:nvSpPr>
          <p:spPr>
            <a:xfrm>
              <a:off x="4515894" y="4886950"/>
              <a:ext cx="86600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Adventitia</a:t>
              </a:r>
            </a:p>
          </p:txBody>
        </p:sp>
        <p:sp>
          <p:nvSpPr>
            <p:cNvPr id="11" name="TextBox 89">
              <a:extLst>
                <a:ext uri="{FF2B5EF4-FFF2-40B4-BE49-F238E27FC236}">
                  <a16:creationId xmlns:a16="http://schemas.microsoft.com/office/drawing/2014/main" id="{FCE8833C-B142-AAE0-A164-E9CEBE60D760}"/>
                </a:ext>
              </a:extLst>
            </p:cNvPr>
            <p:cNvSpPr txBox="1"/>
            <p:nvPr/>
          </p:nvSpPr>
          <p:spPr>
            <a:xfrm>
              <a:off x="4694451" y="3999114"/>
              <a:ext cx="60869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Media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D463D025-F686-A489-A8C9-C8E59B1918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83937" y="4778167"/>
              <a:ext cx="1715" cy="197835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0EAA52D5-566D-554E-123F-4829B66D3B48}"/>
                </a:ext>
              </a:extLst>
            </p:cNvPr>
            <p:cNvCxnSpPr>
              <a:cxnSpLocks/>
            </p:cNvCxnSpPr>
            <p:nvPr/>
          </p:nvCxnSpPr>
          <p:spPr>
            <a:xfrm>
              <a:off x="6816233" y="4254502"/>
              <a:ext cx="0" cy="314013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4" name="TextBox 89">
              <a:extLst>
                <a:ext uri="{FF2B5EF4-FFF2-40B4-BE49-F238E27FC236}">
                  <a16:creationId xmlns:a16="http://schemas.microsoft.com/office/drawing/2014/main" id="{9941C0AD-6A73-EEDB-1BFB-98983D8CE9AD}"/>
                </a:ext>
              </a:extLst>
            </p:cNvPr>
            <p:cNvSpPr txBox="1"/>
            <p:nvPr/>
          </p:nvSpPr>
          <p:spPr>
            <a:xfrm>
              <a:off x="5843336" y="4641903"/>
              <a:ext cx="60869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Intima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09EF9CB9-15DC-ED64-CA25-76972B3BB3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14657" y="4754804"/>
              <a:ext cx="363742" cy="4117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9" name="TextBox 89">
              <a:extLst>
                <a:ext uri="{FF2B5EF4-FFF2-40B4-BE49-F238E27FC236}">
                  <a16:creationId xmlns:a16="http://schemas.microsoft.com/office/drawing/2014/main" id="{F24A4388-EAE0-CC4C-A800-85F8357E0F42}"/>
                </a:ext>
              </a:extLst>
            </p:cNvPr>
            <p:cNvSpPr txBox="1"/>
            <p:nvPr/>
          </p:nvSpPr>
          <p:spPr>
            <a:xfrm>
              <a:off x="6229234" y="4916182"/>
              <a:ext cx="86600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Adventitia</a:t>
              </a:r>
            </a:p>
          </p:txBody>
        </p:sp>
        <p:sp>
          <p:nvSpPr>
            <p:cNvPr id="20" name="TextBox 89">
              <a:extLst>
                <a:ext uri="{FF2B5EF4-FFF2-40B4-BE49-F238E27FC236}">
                  <a16:creationId xmlns:a16="http://schemas.microsoft.com/office/drawing/2014/main" id="{DD325EEE-F5CA-1A96-CE6F-CCBCD3BB9841}"/>
                </a:ext>
              </a:extLst>
            </p:cNvPr>
            <p:cNvSpPr txBox="1"/>
            <p:nvPr/>
          </p:nvSpPr>
          <p:spPr>
            <a:xfrm>
              <a:off x="6452032" y="4039058"/>
              <a:ext cx="60869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328605" hangingPunct="0"/>
              <a:r>
                <a:rPr lang="en-US" sz="800" b="1" dirty="0">
                  <a:solidFill>
                    <a:schemeClr val="bg1"/>
                  </a:solidFill>
                </a:rPr>
                <a:t>Media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B128FBF5-C2D6-390A-3B39-C6E8D121758E}"/>
                </a:ext>
              </a:extLst>
            </p:cNvPr>
            <p:cNvCxnSpPr>
              <a:cxnSpLocks/>
            </p:cNvCxnSpPr>
            <p:nvPr/>
          </p:nvCxnSpPr>
          <p:spPr>
            <a:xfrm>
              <a:off x="4289062" y="2729454"/>
              <a:ext cx="0" cy="314013"/>
            </a:xfrm>
            <a:prstGeom prst="straightConnector1">
              <a:avLst/>
            </a:prstGeom>
            <a:noFill/>
            <a:ln w="28575" cap="flat">
              <a:solidFill>
                <a:schemeClr val="bg1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FD4768DB-1038-F8EC-BA32-52568DAEACB4}"/>
                </a:ext>
              </a:extLst>
            </p:cNvPr>
            <p:cNvGrpSpPr/>
            <p:nvPr/>
          </p:nvGrpSpPr>
          <p:grpSpPr>
            <a:xfrm>
              <a:off x="4458110" y="2524038"/>
              <a:ext cx="3542247" cy="1823410"/>
              <a:chOff x="7482209" y="1327636"/>
              <a:chExt cx="3542247" cy="1823410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DF982D5-7543-ADFA-3DBF-5781F49ACB12}"/>
                  </a:ext>
                </a:extLst>
              </p:cNvPr>
              <p:cNvSpPr txBox="1"/>
              <p:nvPr/>
            </p:nvSpPr>
            <p:spPr>
              <a:xfrm>
                <a:off x="7482209" y="1327637"/>
                <a:ext cx="31542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DengXian" panose="02010600030101010101" pitchFamily="2" charset="-122"/>
                  </a:rPr>
                  <a:t>A</a:t>
                </a:r>
                <a:endParaRPr 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AA7AF84-61C2-9FC6-34E1-3940F4D3C047}"/>
                  </a:ext>
                </a:extLst>
              </p:cNvPr>
              <p:cNvSpPr txBox="1"/>
              <p:nvPr/>
            </p:nvSpPr>
            <p:spPr>
              <a:xfrm>
                <a:off x="9107321" y="1327636"/>
                <a:ext cx="31542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DengXian" panose="02010600030101010101" pitchFamily="2" charset="-122"/>
                  </a:rPr>
                  <a:t>B</a:t>
                </a:r>
                <a:endParaRPr lang="en-US" sz="1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DF401681-5544-598F-2652-E07050E585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92897" y="2179935"/>
                <a:ext cx="0" cy="314013"/>
              </a:xfrm>
              <a:prstGeom prst="straightConnector1">
                <a:avLst/>
              </a:prstGeom>
              <a:noFill/>
              <a:ln w="28575" cap="flat">
                <a:solidFill>
                  <a:schemeClr val="bg1"/>
                </a:solidFill>
                <a:prstDash val="solid"/>
                <a:miter lim="400000"/>
                <a:tailEnd type="triangle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  <p:sp>
            <p:nvSpPr>
              <p:cNvPr id="28" name="TextBox 89">
                <a:extLst>
                  <a:ext uri="{FF2B5EF4-FFF2-40B4-BE49-F238E27FC236}">
                    <a16:creationId xmlns:a16="http://schemas.microsoft.com/office/drawing/2014/main" id="{ADA1BB9A-0BC0-186A-49D5-E82578B29CE8}"/>
                  </a:ext>
                </a:extLst>
              </p:cNvPr>
              <p:cNvSpPr txBox="1"/>
              <p:nvPr/>
            </p:nvSpPr>
            <p:spPr>
              <a:xfrm>
                <a:off x="8570223" y="1995474"/>
                <a:ext cx="60869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28605" hangingPunct="0"/>
                <a:r>
                  <a:rPr lang="en-US" sz="800" b="1" dirty="0">
                    <a:solidFill>
                      <a:schemeClr val="bg1"/>
                    </a:solidFill>
                  </a:rPr>
                  <a:t>Media</a:t>
                </a:r>
              </a:p>
            </p:txBody>
          </p: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24061ED5-310B-1412-D5CA-E0C977B738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57097" y="2721405"/>
                <a:ext cx="363742" cy="4117"/>
              </a:xfrm>
              <a:prstGeom prst="straightConnector1">
                <a:avLst/>
              </a:prstGeom>
              <a:noFill/>
              <a:ln w="28575" cap="flat">
                <a:solidFill>
                  <a:schemeClr val="bg1"/>
                </a:solidFill>
                <a:prstDash val="solid"/>
                <a:miter lim="400000"/>
                <a:tailEnd type="triangle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  <p:sp>
            <p:nvSpPr>
              <p:cNvPr id="30" name="TextBox 89">
                <a:extLst>
                  <a:ext uri="{FF2B5EF4-FFF2-40B4-BE49-F238E27FC236}">
                    <a16:creationId xmlns:a16="http://schemas.microsoft.com/office/drawing/2014/main" id="{286F56FF-304F-DE03-0768-F86CE428CDED}"/>
                  </a:ext>
                </a:extLst>
              </p:cNvPr>
              <p:cNvSpPr txBox="1"/>
              <p:nvPr/>
            </p:nvSpPr>
            <p:spPr>
              <a:xfrm>
                <a:off x="7869971" y="2621732"/>
                <a:ext cx="60869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28605" hangingPunct="0"/>
                <a:r>
                  <a:rPr lang="en-US" sz="800" b="1" dirty="0">
                    <a:solidFill>
                      <a:schemeClr val="bg1"/>
                    </a:solidFill>
                  </a:rPr>
                  <a:t>Intima</a:t>
                </a:r>
              </a:p>
            </p:txBody>
          </p: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9B1170DD-1FDE-A457-4E1C-E042F4DE329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896386" y="2678409"/>
                <a:ext cx="1715" cy="197835"/>
              </a:xfrm>
              <a:prstGeom prst="straightConnector1">
                <a:avLst/>
              </a:prstGeom>
              <a:noFill/>
              <a:ln w="28575" cap="flat">
                <a:solidFill>
                  <a:schemeClr val="bg1"/>
                </a:solidFill>
                <a:prstDash val="solid"/>
                <a:miter lim="400000"/>
                <a:tailEnd type="triangle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  <p:sp>
            <p:nvSpPr>
              <p:cNvPr id="32" name="TextBox 89">
                <a:extLst>
                  <a:ext uri="{FF2B5EF4-FFF2-40B4-BE49-F238E27FC236}">
                    <a16:creationId xmlns:a16="http://schemas.microsoft.com/office/drawing/2014/main" id="{B742AEF9-FAF3-9F69-FC88-DFE6E5D3BA21}"/>
                  </a:ext>
                </a:extLst>
              </p:cNvPr>
              <p:cNvSpPr txBox="1"/>
              <p:nvPr/>
            </p:nvSpPr>
            <p:spPr>
              <a:xfrm>
                <a:off x="8397623" y="2827556"/>
                <a:ext cx="86600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28605" hangingPunct="0"/>
                <a:r>
                  <a:rPr lang="en-US" sz="800" b="1" dirty="0">
                    <a:solidFill>
                      <a:schemeClr val="bg1"/>
                    </a:solidFill>
                  </a:rPr>
                  <a:t>Adventitia</a:t>
                </a:r>
              </a:p>
            </p:txBody>
          </p:sp>
          <p:sp>
            <p:nvSpPr>
              <p:cNvPr id="33" name="TextBox 89">
                <a:extLst>
                  <a:ext uri="{FF2B5EF4-FFF2-40B4-BE49-F238E27FC236}">
                    <a16:creationId xmlns:a16="http://schemas.microsoft.com/office/drawing/2014/main" id="{4632F77C-CA11-21C8-6D52-634D29C684E5}"/>
                  </a:ext>
                </a:extLst>
              </p:cNvPr>
              <p:cNvSpPr txBox="1"/>
              <p:nvPr/>
            </p:nvSpPr>
            <p:spPr>
              <a:xfrm>
                <a:off x="10158449" y="2935602"/>
                <a:ext cx="86600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28605" hangingPunct="0"/>
                <a:r>
                  <a:rPr lang="en-US" sz="800" b="1" dirty="0">
                    <a:solidFill>
                      <a:schemeClr val="bg1"/>
                    </a:solidFill>
                  </a:rPr>
                  <a:t>Adventitia</a:t>
                </a:r>
              </a:p>
            </p:txBody>
          </p: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BB1B011D-CB7A-A341-FDEA-1E5566297D4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697344" y="2787542"/>
                <a:ext cx="1715" cy="197835"/>
              </a:xfrm>
              <a:prstGeom prst="straightConnector1">
                <a:avLst/>
              </a:prstGeom>
              <a:noFill/>
              <a:ln w="28575" cap="flat">
                <a:solidFill>
                  <a:schemeClr val="bg1"/>
                </a:solidFill>
                <a:prstDash val="solid"/>
                <a:miter lim="400000"/>
                <a:tailEnd type="triangle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80E04EA3-9599-7BC0-E1E4-2D793BFEC1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44937" y="2782725"/>
                <a:ext cx="452610" cy="0"/>
              </a:xfrm>
              <a:prstGeom prst="straightConnector1">
                <a:avLst/>
              </a:prstGeom>
              <a:noFill/>
              <a:ln w="28575" cap="flat">
                <a:solidFill>
                  <a:schemeClr val="bg1"/>
                </a:solidFill>
                <a:prstDash val="solid"/>
                <a:miter lim="400000"/>
                <a:tailEnd type="triangle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</p:grpSp>
      </p:grpSp>
      <p:pic>
        <p:nvPicPr>
          <p:cNvPr id="25" name="Picture 24" descr="A video game of a tunnel&#10;&#10;Description automatically generated">
            <a:extLst>
              <a:ext uri="{FF2B5EF4-FFF2-40B4-BE49-F238E27FC236}">
                <a16:creationId xmlns:a16="http://schemas.microsoft.com/office/drawing/2014/main" id="{C4F63E0C-26C5-F47D-6843-6D9A51D97B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8" r="4793" b="6738"/>
          <a:stretch/>
        </p:blipFill>
        <p:spPr>
          <a:xfrm>
            <a:off x="4217803" y="2149706"/>
            <a:ext cx="1914713" cy="1824022"/>
          </a:xfrm>
          <a:prstGeom prst="rect">
            <a:avLst/>
          </a:prstGeom>
        </p:spPr>
      </p:pic>
      <p:pic>
        <p:nvPicPr>
          <p:cNvPr id="41" name="Picture 40" descr="A close-up of a circular object&#10;&#10;Description automatically generated">
            <a:extLst>
              <a:ext uri="{FF2B5EF4-FFF2-40B4-BE49-F238E27FC236}">
                <a16:creationId xmlns:a16="http://schemas.microsoft.com/office/drawing/2014/main" id="{F2AA290B-B7B8-E147-F806-7B2D78B9AE6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3456" y="3684080"/>
            <a:ext cx="1244600" cy="1257300"/>
          </a:xfrm>
          <a:prstGeom prst="rect">
            <a:avLst/>
          </a:prstGeom>
        </p:spPr>
      </p:pic>
      <p:pic>
        <p:nvPicPr>
          <p:cNvPr id="45" name="Picture 44" descr="A close up of an ultrasound&#10;&#10;Description automatically generated">
            <a:extLst>
              <a:ext uri="{FF2B5EF4-FFF2-40B4-BE49-F238E27FC236}">
                <a16:creationId xmlns:a16="http://schemas.microsoft.com/office/drawing/2014/main" id="{6EA1BCB1-85D4-B2E6-FB21-92180A3807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5979" y="3680596"/>
            <a:ext cx="1214416" cy="1257300"/>
          </a:xfrm>
          <a:prstGeom prst="rect">
            <a:avLst/>
          </a:prstGeom>
        </p:spPr>
      </p:pic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1FD4338E-252B-0313-D891-53E1F587C525}"/>
              </a:ext>
            </a:extLst>
          </p:cNvPr>
          <p:cNvCxnSpPr>
            <a:cxnSpLocks/>
          </p:cNvCxnSpPr>
          <p:nvPr/>
        </p:nvCxnSpPr>
        <p:spPr>
          <a:xfrm>
            <a:off x="5412373" y="4059054"/>
            <a:ext cx="238659" cy="0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1877DAD6-C3A7-1C05-4B34-A7828A77A266}"/>
              </a:ext>
            </a:extLst>
          </p:cNvPr>
          <p:cNvCxnSpPr>
            <a:cxnSpLocks/>
          </p:cNvCxnSpPr>
          <p:nvPr/>
        </p:nvCxnSpPr>
        <p:spPr>
          <a:xfrm>
            <a:off x="5809154" y="3482101"/>
            <a:ext cx="0" cy="208249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1784F075-3026-C544-F22A-FDEC94055B4E}"/>
              </a:ext>
            </a:extLst>
          </p:cNvPr>
          <p:cNvCxnSpPr>
            <a:cxnSpLocks/>
          </p:cNvCxnSpPr>
          <p:nvPr/>
        </p:nvCxnSpPr>
        <p:spPr>
          <a:xfrm flipV="1">
            <a:off x="5790988" y="4109898"/>
            <a:ext cx="0" cy="199161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54" name="TextBox 89">
            <a:extLst>
              <a:ext uri="{FF2B5EF4-FFF2-40B4-BE49-F238E27FC236}">
                <a16:creationId xmlns:a16="http://schemas.microsoft.com/office/drawing/2014/main" id="{744247EE-C712-EF1E-766D-7B912F8F4DE8}"/>
              </a:ext>
            </a:extLst>
          </p:cNvPr>
          <p:cNvSpPr txBox="1"/>
          <p:nvPr/>
        </p:nvSpPr>
        <p:spPr>
          <a:xfrm>
            <a:off x="5514869" y="3286322"/>
            <a:ext cx="60869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Media</a:t>
            </a:r>
          </a:p>
        </p:txBody>
      </p:sp>
      <p:sp>
        <p:nvSpPr>
          <p:cNvPr id="55" name="TextBox 89">
            <a:extLst>
              <a:ext uri="{FF2B5EF4-FFF2-40B4-BE49-F238E27FC236}">
                <a16:creationId xmlns:a16="http://schemas.microsoft.com/office/drawing/2014/main" id="{D8455DFB-4C67-11C0-E898-41E9C5BE7711}"/>
              </a:ext>
            </a:extLst>
          </p:cNvPr>
          <p:cNvSpPr txBox="1"/>
          <p:nvPr/>
        </p:nvSpPr>
        <p:spPr>
          <a:xfrm>
            <a:off x="4908310" y="3934538"/>
            <a:ext cx="60869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Intima</a:t>
            </a:r>
          </a:p>
        </p:txBody>
      </p:sp>
      <p:sp>
        <p:nvSpPr>
          <p:cNvPr id="56" name="TextBox 89">
            <a:extLst>
              <a:ext uri="{FF2B5EF4-FFF2-40B4-BE49-F238E27FC236}">
                <a16:creationId xmlns:a16="http://schemas.microsoft.com/office/drawing/2014/main" id="{887727D3-2BED-2A3B-3151-F2FE9770EFCB}"/>
              </a:ext>
            </a:extLst>
          </p:cNvPr>
          <p:cNvSpPr txBox="1"/>
          <p:nvPr/>
        </p:nvSpPr>
        <p:spPr>
          <a:xfrm>
            <a:off x="5339640" y="4313257"/>
            <a:ext cx="86600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Adventitia</a:t>
            </a:r>
          </a:p>
        </p:txBody>
      </p:sp>
      <p:sp>
        <p:nvSpPr>
          <p:cNvPr id="57" name="TextBox 89">
            <a:extLst>
              <a:ext uri="{FF2B5EF4-FFF2-40B4-BE49-F238E27FC236}">
                <a16:creationId xmlns:a16="http://schemas.microsoft.com/office/drawing/2014/main" id="{AA6EB155-C8E6-8F16-B848-0E51DAEAD69A}"/>
              </a:ext>
            </a:extLst>
          </p:cNvPr>
          <p:cNvSpPr txBox="1"/>
          <p:nvPr/>
        </p:nvSpPr>
        <p:spPr>
          <a:xfrm>
            <a:off x="7712289" y="3294771"/>
            <a:ext cx="60869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Media</a:t>
            </a:r>
          </a:p>
        </p:txBody>
      </p:sp>
      <p:sp>
        <p:nvSpPr>
          <p:cNvPr id="58" name="TextBox 89">
            <a:extLst>
              <a:ext uri="{FF2B5EF4-FFF2-40B4-BE49-F238E27FC236}">
                <a16:creationId xmlns:a16="http://schemas.microsoft.com/office/drawing/2014/main" id="{6B533083-E292-3F4D-033E-3949F2D76A07}"/>
              </a:ext>
            </a:extLst>
          </p:cNvPr>
          <p:cNvSpPr txBox="1"/>
          <p:nvPr/>
        </p:nvSpPr>
        <p:spPr>
          <a:xfrm>
            <a:off x="7204334" y="4050112"/>
            <a:ext cx="60869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Intima</a:t>
            </a:r>
          </a:p>
        </p:txBody>
      </p:sp>
      <p:sp>
        <p:nvSpPr>
          <p:cNvPr id="59" name="TextBox 89">
            <a:extLst>
              <a:ext uri="{FF2B5EF4-FFF2-40B4-BE49-F238E27FC236}">
                <a16:creationId xmlns:a16="http://schemas.microsoft.com/office/drawing/2014/main" id="{7C75D264-F5FC-E19E-5FFD-62505AE90F69}"/>
              </a:ext>
            </a:extLst>
          </p:cNvPr>
          <p:cNvSpPr txBox="1"/>
          <p:nvPr/>
        </p:nvSpPr>
        <p:spPr>
          <a:xfrm>
            <a:off x="6970437" y="4305056"/>
            <a:ext cx="86600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328605" hangingPunct="0"/>
            <a:r>
              <a:rPr lang="en-US" sz="800" b="1" dirty="0">
                <a:solidFill>
                  <a:schemeClr val="bg1"/>
                </a:solidFill>
              </a:rPr>
              <a:t>Adventitia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6DEB76F4-7D64-8562-3019-B9CB22D290F3}"/>
              </a:ext>
            </a:extLst>
          </p:cNvPr>
          <p:cNvCxnSpPr>
            <a:cxnSpLocks/>
          </p:cNvCxnSpPr>
          <p:nvPr/>
        </p:nvCxnSpPr>
        <p:spPr>
          <a:xfrm>
            <a:off x="7673245" y="4406605"/>
            <a:ext cx="261695" cy="0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34D725DB-2056-099E-23BD-53E6875DEE7A}"/>
              </a:ext>
            </a:extLst>
          </p:cNvPr>
          <p:cNvCxnSpPr>
            <a:cxnSpLocks/>
          </p:cNvCxnSpPr>
          <p:nvPr/>
        </p:nvCxnSpPr>
        <p:spPr>
          <a:xfrm>
            <a:off x="7696281" y="4168474"/>
            <a:ext cx="238659" cy="0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91157B83-9DC8-DB15-8029-52EF0F31F75B}"/>
              </a:ext>
            </a:extLst>
          </p:cNvPr>
          <p:cNvCxnSpPr>
            <a:cxnSpLocks/>
          </p:cNvCxnSpPr>
          <p:nvPr/>
        </p:nvCxnSpPr>
        <p:spPr>
          <a:xfrm>
            <a:off x="8075613" y="3458151"/>
            <a:ext cx="0" cy="220224"/>
          </a:xfrm>
          <a:prstGeom prst="straightConnector1">
            <a:avLst/>
          </a:prstGeom>
          <a:noFill/>
          <a:ln w="28575" cap="flat">
            <a:solidFill>
              <a:schemeClr val="bg1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D9F6332-1E07-99A8-FB62-A0E33281C1B7}"/>
              </a:ext>
            </a:extLst>
          </p:cNvPr>
          <p:cNvSpPr txBox="1"/>
          <p:nvPr/>
        </p:nvSpPr>
        <p:spPr>
          <a:xfrm>
            <a:off x="3416791" y="5091185"/>
            <a:ext cx="533286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ormal wall morphology, fine wall, and plaque structures on IVUS vs. OCT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A) Normal wall on OCT; (B) Normal wall on IVUS</a:t>
            </a:r>
            <a:endParaRPr lang="en-US" sz="12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B20C108-E342-B939-B844-DFE7040B2ED7}"/>
              </a:ext>
            </a:extLst>
          </p:cNvPr>
          <p:cNvSpPr/>
          <p:nvPr/>
        </p:nvSpPr>
        <p:spPr>
          <a:xfrm>
            <a:off x="5417164" y="3009563"/>
            <a:ext cx="301996" cy="276759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C720A3F-B169-E949-406D-F0581CA37BFE}"/>
              </a:ext>
            </a:extLst>
          </p:cNvPr>
          <p:cNvSpPr/>
          <p:nvPr/>
        </p:nvSpPr>
        <p:spPr>
          <a:xfrm>
            <a:off x="7427464" y="3161963"/>
            <a:ext cx="301996" cy="276759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9D2CC8D-7A56-F3E9-A014-E97E6E20BB21}"/>
              </a:ext>
            </a:extLst>
          </p:cNvPr>
          <p:cNvSpPr txBox="1"/>
          <p:nvPr/>
        </p:nvSpPr>
        <p:spPr>
          <a:xfrm>
            <a:off x="4174621" y="2129913"/>
            <a:ext cx="6556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</a:t>
            </a:r>
            <a:r>
              <a:rPr lang="en-US" sz="1200" b="1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</a:t>
            </a:r>
            <a:r>
              <a:rPr lang="en-US" sz="12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6155340-C716-3953-D045-EAD59AAEF79F}"/>
              </a:ext>
            </a:extLst>
          </p:cNvPr>
          <p:cNvSpPr txBox="1"/>
          <p:nvPr/>
        </p:nvSpPr>
        <p:spPr>
          <a:xfrm>
            <a:off x="6274655" y="2139317"/>
            <a:ext cx="6556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</a:t>
            </a:r>
            <a:r>
              <a:rPr lang="en-US" sz="1200" b="1" kern="100" dirty="0">
                <a:solidFill>
                  <a:schemeClr val="bg1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B</a:t>
            </a:r>
            <a:r>
              <a:rPr lang="en-US" sz="12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</a:t>
            </a:r>
            <a:endParaRPr lang="en-US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7770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855</TotalTime>
  <Words>367</Words>
  <Application>Microsoft Office PowerPoint</Application>
  <PresentationFormat>Widescreen</PresentationFormat>
  <Paragraphs>6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Miam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VEDI, YASH VARDHAN</dc:creator>
  <cp:lastModifiedBy>Lawrence, Amy (ELS-EXE)</cp:lastModifiedBy>
  <cp:revision>206</cp:revision>
  <cp:lastPrinted>2024-08-22T22:07:17Z</cp:lastPrinted>
  <dcterms:created xsi:type="dcterms:W3CDTF">2024-07-12T14:53:53Z</dcterms:created>
  <dcterms:modified xsi:type="dcterms:W3CDTF">2025-01-17T18:29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49ac42a-3eb4-4074-b885-aea26bd6241e_Enabled">
    <vt:lpwstr>true</vt:lpwstr>
  </property>
  <property fmtid="{D5CDD505-2E9C-101B-9397-08002B2CF9AE}" pid="3" name="MSIP_Label_549ac42a-3eb4-4074-b885-aea26bd6241e_SetDate">
    <vt:lpwstr>2025-01-17T18:29:41Z</vt:lpwstr>
  </property>
  <property fmtid="{D5CDD505-2E9C-101B-9397-08002B2CF9AE}" pid="4" name="MSIP_Label_549ac42a-3eb4-4074-b885-aea26bd6241e_Method">
    <vt:lpwstr>Standard</vt:lpwstr>
  </property>
  <property fmtid="{D5CDD505-2E9C-101B-9397-08002B2CF9AE}" pid="5" name="MSIP_Label_549ac42a-3eb4-4074-b885-aea26bd6241e_Name">
    <vt:lpwstr>General Business</vt:lpwstr>
  </property>
  <property fmtid="{D5CDD505-2E9C-101B-9397-08002B2CF9AE}" pid="6" name="MSIP_Label_549ac42a-3eb4-4074-b885-aea26bd6241e_SiteId">
    <vt:lpwstr>9274ee3f-9425-4109-a27f-9fb15c10675d</vt:lpwstr>
  </property>
  <property fmtid="{D5CDD505-2E9C-101B-9397-08002B2CF9AE}" pid="7" name="MSIP_Label_549ac42a-3eb4-4074-b885-aea26bd6241e_ActionId">
    <vt:lpwstr>5073f95f-2a96-4711-a964-e33128b6e2d9</vt:lpwstr>
  </property>
  <property fmtid="{D5CDD505-2E9C-101B-9397-08002B2CF9AE}" pid="8" name="MSIP_Label_549ac42a-3eb4-4074-b885-aea26bd6241e_ContentBits">
    <vt:lpwstr>0</vt:lpwstr>
  </property>
</Properties>
</file>